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022FD-4780-4D52-B09B-7C46D2372C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FCC34-F028-4AED-A653-26A1783267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BB70A2-FC9D-4754-90F4-99A026DDBE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F701A7-5F0E-4FAE-BD94-02F201D809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768152-FA7C-4210-B8B6-6F4C53DBF6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313A4-3B15-4B03-9131-AE56C8E000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CBCD9-4AAB-4E6B-BB02-2589011B5B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32227-9E30-43DE-ADF5-78A1A405D6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AC6EB8-258D-43BE-B16D-0544751F85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C4F76-F857-481F-920A-EE0E390F87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EE6F54-0F6C-4BC8-9B31-0058BA4FE7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5AF2C-43C8-43A6-AF3E-5183481E13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9EFED7-6ECD-404C-9D08-A6B3C04BBB9B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5489640" cy="1062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upplement Figure 1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图片 2" descr="Fig-s1"/>
          <p:cNvPicPr/>
          <p:nvPr/>
        </p:nvPicPr>
        <p:blipFill>
          <a:blip r:embed="rId1"/>
          <a:srcRect l="0" t="0" r="33189" b="32303"/>
          <a:stretch/>
        </p:blipFill>
        <p:spPr>
          <a:xfrm>
            <a:off x="1144440" y="1189080"/>
            <a:ext cx="6855120" cy="5559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30200" y="112680"/>
            <a:ext cx="5664240" cy="1170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upplement Figure 2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图片 2" descr="Fig-s2"/>
          <p:cNvPicPr/>
          <p:nvPr/>
        </p:nvPicPr>
        <p:blipFill>
          <a:blip r:embed="rId1"/>
          <a:srcRect l="0" t="0" r="29516" b="30532"/>
          <a:stretch/>
        </p:blipFill>
        <p:spPr>
          <a:xfrm>
            <a:off x="1582560" y="1197000"/>
            <a:ext cx="6383520" cy="567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363600" y="100080"/>
            <a:ext cx="5178240" cy="9921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upplement Figure 3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图片 2" descr="Fig-s3"/>
          <p:cNvPicPr/>
          <p:nvPr/>
        </p:nvPicPr>
        <p:blipFill>
          <a:blip r:embed="rId1"/>
          <a:srcRect l="4620" t="0" r="32932" b="32001"/>
          <a:stretch/>
        </p:blipFill>
        <p:spPr>
          <a:xfrm>
            <a:off x="988920" y="1263600"/>
            <a:ext cx="7462800" cy="5541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44240" y="126720"/>
            <a:ext cx="5421240" cy="1089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upplement Figure 4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图片 2" descr="Fig-s4"/>
          <p:cNvPicPr/>
          <p:nvPr/>
        </p:nvPicPr>
        <p:blipFill>
          <a:blip r:embed="rId1"/>
          <a:srcRect l="7033" t="0" r="32824" b="32855"/>
          <a:stretch/>
        </p:blipFill>
        <p:spPr>
          <a:xfrm>
            <a:off x="453960" y="1082520"/>
            <a:ext cx="8508960" cy="555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5315040" cy="846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upplement Figure 5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图片 2" descr="Fig-s5"/>
          <p:cNvPicPr/>
          <p:nvPr/>
        </p:nvPicPr>
        <p:blipFill>
          <a:blip r:embed="rId1"/>
          <a:srcRect l="9634" t="0" r="32822" b="31993"/>
          <a:stretch/>
        </p:blipFill>
        <p:spPr>
          <a:xfrm>
            <a:off x="250920" y="1276200"/>
            <a:ext cx="8618400" cy="5265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8-25T22:47:56Z</dcterms:created>
  <dc:creator>Sowmya S.</dc:creator>
  <dc:description/>
  <dc:language>en-US</dc:language>
  <cp:lastModifiedBy>0015620</cp:lastModifiedBy>
  <dcterms:modified xsi:type="dcterms:W3CDTF">2019-09-05T03:56:52Z</dcterms:modified>
  <cp:revision>3</cp:revision>
  <dc:subject/>
  <dc:title>Figur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584</vt:lpwstr>
  </property>
</Properties>
</file>